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618" r:id="rId2"/>
    <p:sldId id="603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58" y="2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9DC97D-4B61-493C-9DB7-1B6CCCEE241E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8A83F6-715D-4960-85D4-5FA05967796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9747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F5915C-CD2D-4D0D-8004-C3F28A93520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5895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F5915C-CD2D-4D0D-8004-C3F28A93520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8966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9E030-C4E8-3F0B-4B37-A760897325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009F75E-E566-75C3-C66A-465A2A2310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750A7C-9557-3BF8-71AA-04C0347FA0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4091E-4885-41DD-B919-FDDDBAE50B8A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B86F1A-84F2-EC12-88A2-1049BEEBF2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B20508-17AB-B5CF-6224-3D58C4D3F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4C583-EC7F-43F6-B187-BF208F990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1832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FE05AB-8937-E181-F8F1-D6E2AC79EE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EE9C0C-A3B9-57DC-F1C0-DB76628E49D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903006-55A4-0A07-2F99-06F4E9327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4091E-4885-41DD-B919-FDDDBAE50B8A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DBD48E-9BC0-0D6A-F3E5-E80FB86F1D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30DCA8-0865-5D72-AE0B-2D06CD76E3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4C583-EC7F-43F6-B187-BF208F990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008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6C04AF-99E0-71F3-AF63-90DE023F0E1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315A22-95D1-776E-91AF-C7BB5165CD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DA2E1B-0B78-279B-DE8F-8121BBB1B5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4091E-4885-41DD-B919-FDDDBAE50B8A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AFC66E-C057-7A82-2EBA-73574F5B27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C8D71D-65E1-AE51-2AA7-CF3E712E80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4C583-EC7F-43F6-B187-BF208F990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6789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3A80C0-DC36-6DE6-ADB4-672D7B8541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3EE915-08AD-0A20-115D-3584E312AB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2965D9-A53A-860F-3411-AA377DB4C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4091E-4885-41DD-B919-FDDDBAE50B8A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1574F1-463B-3F68-5AD4-00FFFC589A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4C17BA-2D0B-B6B9-1B3B-37D9454F52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4C583-EC7F-43F6-B187-BF208F990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036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B01352-5EA6-B69F-3BAB-11E00AEE80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029DD7-CFBF-56CF-64A7-431F3C6F47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F34926-83EF-419F-6421-519EA93FDB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4091E-4885-41DD-B919-FDDDBAE50B8A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16E363-D25D-6287-4227-FBABF7F5AB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D39A02-882A-0C6C-0443-79EFB4C6D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4C583-EC7F-43F6-B187-BF208F990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5193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21451B-9621-D137-D436-8316E139D4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74F5EE-9151-F353-A89C-E8117AA266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6FF03E-7361-9A52-CCB6-A1880C7CA1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53EF2D-4155-33E6-28CC-C8C1BAB27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4091E-4885-41DD-B919-FDDDBAE50B8A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50ED53A-04FF-F266-2731-B8A0549AC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CB7528-7E13-B1C2-DB43-AB0EB8500A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4C583-EC7F-43F6-B187-BF208F990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179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C17D9E-7012-7BA5-339D-08F7E65865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2512E8-ED4C-8EED-35E5-9CBB90B93F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C55664-E0BE-853F-92B8-40B543CF15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6FFFB59-9DF3-55BB-44AA-87DDC596F7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29BF92E-1459-67F4-A40E-65D5393F9D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FB8BF61-727D-FD6A-2E10-1A1D645A2B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4091E-4885-41DD-B919-FDDDBAE50B8A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5E1416B-27FC-1A98-9A15-3A1E9606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1515E60-C1DD-C5D2-6086-377622844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4C583-EC7F-43F6-B187-BF208F990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2921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8B3258-FC8D-52EF-0C25-841C3C7238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503278C-E34C-3BF8-CE2C-C805940CC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4091E-4885-41DD-B919-FDDDBAE50B8A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B666603-A19B-EDEB-430C-659C74B32F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4713282-4AD9-9286-E062-A21B2C9CA7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4C583-EC7F-43F6-B187-BF208F990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1790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B2C83B8-27C6-4B9B-ABFA-3F03C7D8B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4091E-4885-41DD-B919-FDDDBAE50B8A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061FCA-6E8A-D188-7B26-9EA475E6B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4E6896F-8B00-A4E5-0673-863B8382DF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4C583-EC7F-43F6-B187-BF208F990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6568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8BB6E5-A299-97A8-DA2C-2E3DB435BB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CC89A5-D24B-0963-5475-A7946B86A17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24CCD6-A16D-8F21-8156-9047C65A51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D29EFC-4751-75A9-9C1F-743CB72B09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4091E-4885-41DD-B919-FDDDBAE50B8A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2BFDFA-2467-64F0-493B-2BC8535829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A11001-635E-F715-66D9-4593C30BC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4C583-EC7F-43F6-B187-BF208F990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49391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A4FBC6-4829-DCCF-3FE6-7BBE8DAD3C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6150AD-9ECB-705A-8B5B-31C0F70CE3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D45F46-B341-31B3-84A6-A02DEFA934B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777509-A78B-8351-BE56-07A8B59FC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4091E-4885-41DD-B919-FDDDBAE50B8A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7809D8-770F-F4B0-8B0B-15648E05C3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AF508D-246A-B492-1434-07A8E79833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14C583-EC7F-43F6-B187-BF208F990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003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98C9F1C-93B6-E2B8-036C-B1FAE6742C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418352-417D-7F91-6DB6-787B048C1C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718100-208F-AD51-0198-4F4A05C1A5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E4091E-4885-41DD-B919-FDDDBAE50B8A}" type="datetimeFigureOut">
              <a:rPr lang="en-US" smtClean="0"/>
              <a:t>4/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C2F05E-DBA5-38E8-157A-CC08317E3A0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BD15AB-9067-C50B-84EE-D6C8423F832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14C583-EC7F-43F6-B187-BF208F9905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0003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07/relationships/hdphoto" Target="../media/hdphoto4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2.png"/><Relationship Id="rId10" Type="http://schemas.openxmlformats.org/officeDocument/2006/relationships/image" Target="../media/image5.tif"/><Relationship Id="rId4" Type="http://schemas.microsoft.com/office/2007/relationships/hdphoto" Target="../media/hdphoto1.wdp"/><Relationship Id="rId9" Type="http://schemas.openxmlformats.org/officeDocument/2006/relationships/image" Target="../media/image4.tif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07/relationships/hdphoto" Target="../media/hdphoto4.wdp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2.png"/><Relationship Id="rId10" Type="http://schemas.openxmlformats.org/officeDocument/2006/relationships/image" Target="../media/image5.tif"/><Relationship Id="rId4" Type="http://schemas.microsoft.com/office/2007/relationships/hdphoto" Target="../media/hdphoto1.wdp"/><Relationship Id="rId9" Type="http://schemas.openxmlformats.org/officeDocument/2006/relationships/image" Target="../media/image4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3B38DDFA-D45F-5343-ED7F-04B5908000BA}"/>
              </a:ext>
            </a:extLst>
          </p:cNvPr>
          <p:cNvGrpSpPr/>
          <p:nvPr/>
        </p:nvGrpSpPr>
        <p:grpSpPr>
          <a:xfrm>
            <a:off x="8507170" y="2462452"/>
            <a:ext cx="2631437" cy="1114229"/>
            <a:chOff x="87229" y="-100806"/>
            <a:chExt cx="4287122" cy="1114229"/>
          </a:xfrm>
        </p:grpSpPr>
        <p:sp>
          <p:nvSpPr>
            <p:cNvPr id="24" name="文本框 16">
              <a:extLst>
                <a:ext uri="{FF2B5EF4-FFF2-40B4-BE49-F238E27FC236}">
                  <a16:creationId xmlns:a16="http://schemas.microsoft.com/office/drawing/2014/main" id="{3D86EA04-02F0-1D4F-9CC7-724F6A88F5E4}"/>
                </a:ext>
              </a:extLst>
            </p:cNvPr>
            <p:cNvSpPr txBox="1"/>
            <p:nvPr/>
          </p:nvSpPr>
          <p:spPr>
            <a:xfrm>
              <a:off x="87229" y="644091"/>
              <a:ext cx="30587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CN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210915-16</a:t>
              </a:r>
              <a:r>
                <a:rPr kumimoji="1" lang="zh-CN" altLang="en-US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 </a:t>
              </a:r>
              <a:r>
                <a:rPr kumimoji="1" lang="en-US" altLang="zh-CN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10%</a:t>
              </a:r>
              <a:r>
                <a:rPr kumimoji="1" lang="zh-CN" altLang="en-US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4" name="文本框 16">
              <a:extLst>
                <a:ext uri="{FF2B5EF4-FFF2-40B4-BE49-F238E27FC236}">
                  <a16:creationId xmlns:a16="http://schemas.microsoft.com/office/drawing/2014/main" id="{3603F464-3D2D-5178-5942-97E83393DDC1}"/>
                </a:ext>
              </a:extLst>
            </p:cNvPr>
            <p:cNvSpPr txBox="1"/>
            <p:nvPr/>
          </p:nvSpPr>
          <p:spPr>
            <a:xfrm>
              <a:off x="135197" y="-100806"/>
              <a:ext cx="423915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CN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210824-26</a:t>
              </a:r>
              <a:r>
                <a:rPr kumimoji="1" lang="zh-CN" altLang="en-US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 </a:t>
              </a:r>
              <a:r>
                <a:rPr kumimoji="1" lang="en-US" altLang="zh-CN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10% + 15%</a:t>
              </a:r>
              <a:r>
                <a:rPr kumimoji="1" lang="zh-CN" altLang="en-US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5" name="文本框 1">
              <a:extLst>
                <a:ext uri="{FF2B5EF4-FFF2-40B4-BE49-F238E27FC236}">
                  <a16:creationId xmlns:a16="http://schemas.microsoft.com/office/drawing/2014/main" id="{D3BAFC20-1A4A-2F51-16D2-13F0290C1D2A}"/>
                </a:ext>
              </a:extLst>
            </p:cNvPr>
            <p:cNvSpPr txBox="1"/>
            <p:nvPr/>
          </p:nvSpPr>
          <p:spPr>
            <a:xfrm>
              <a:off x="133057" y="284459"/>
              <a:ext cx="36541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0810 + 0819 protein</a:t>
              </a:r>
              <a:endParaRPr kumimoji="1"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9E44F3D7-B28D-701C-D241-CE1141EA50F8}"/>
              </a:ext>
            </a:extLst>
          </p:cNvPr>
          <p:cNvGrpSpPr/>
          <p:nvPr/>
        </p:nvGrpSpPr>
        <p:grpSpPr>
          <a:xfrm>
            <a:off x="786020" y="70111"/>
            <a:ext cx="8181933" cy="5320954"/>
            <a:chOff x="3324689" y="884837"/>
            <a:chExt cx="8181933" cy="5320954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AA679C71-6F47-3DC1-7931-F6267F199759}"/>
                </a:ext>
              </a:extLst>
            </p:cNvPr>
            <p:cNvGrpSpPr/>
            <p:nvPr/>
          </p:nvGrpSpPr>
          <p:grpSpPr>
            <a:xfrm>
              <a:off x="3324689" y="884837"/>
              <a:ext cx="8181933" cy="5320954"/>
              <a:chOff x="3324689" y="884837"/>
              <a:chExt cx="8181933" cy="5320954"/>
            </a:xfrm>
          </p:grpSpPr>
          <p:pic>
            <p:nvPicPr>
              <p:cNvPr id="5" name="图片 4" descr="空中有架飞机的黑白照&#10;&#10;低可信度描述已自动生成">
                <a:extLst>
                  <a:ext uri="{FF2B5EF4-FFF2-40B4-BE49-F238E27FC236}">
                    <a16:creationId xmlns:a16="http://schemas.microsoft.com/office/drawing/2014/main" id="{EC6837EF-97D2-1043-9483-6133BA6EC38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</a:extLst>
              </a:blip>
              <a:srcRect l="53186" t="53598" r="28378" b="41344"/>
              <a:stretch/>
            </p:blipFill>
            <p:spPr>
              <a:xfrm flipH="1">
                <a:off x="4085700" y="5715611"/>
                <a:ext cx="2313697" cy="49018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6569A41A-C499-844C-8B4B-5322E64B21E2}"/>
                  </a:ext>
                </a:extLst>
              </p:cNvPr>
              <p:cNvSpPr txBox="1"/>
              <p:nvPr/>
            </p:nvSpPr>
            <p:spPr>
              <a:xfrm>
                <a:off x="6405763" y="5687045"/>
                <a:ext cx="1124026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zh-CN" altLang="en-US" sz="2400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𝛽</a:t>
                </a:r>
                <a:r>
                  <a:rPr kumimoji="1" lang="en-US" altLang="zh-CN" sz="2400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-actin</a:t>
                </a:r>
              </a:p>
            </p:txBody>
          </p:sp>
          <p:pic>
            <p:nvPicPr>
              <p:cNvPr id="57" name="Picture 56" descr="图片包含 水, 旧, 标志, 大&#10;&#10;描述已自动生成">
                <a:extLst>
                  <a:ext uri="{FF2B5EF4-FFF2-40B4-BE49-F238E27FC236}">
                    <a16:creationId xmlns:a16="http://schemas.microsoft.com/office/drawing/2014/main" id="{D8D27A2E-814B-5AEE-E21C-67425489082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50000"/>
                        </a14:imgEffect>
                        <a14:imgEffect>
                          <a14:brightnessContrast bright="40000"/>
                        </a14:imgEffect>
                      </a14:imgLayer>
                    </a14:imgProps>
                  </a:ext>
                </a:extLst>
              </a:blip>
              <a:srcRect l="37209" t="61645" r="44326" b="33591"/>
              <a:stretch/>
            </p:blipFill>
            <p:spPr>
              <a:xfrm flipH="1">
                <a:off x="4085711" y="2754185"/>
                <a:ext cx="2313689" cy="542615"/>
              </a:xfrm>
              <a:custGeom>
                <a:avLst/>
                <a:gdLst>
                  <a:gd name="connsiteX0" fmla="*/ 0 w 2088006"/>
                  <a:gd name="connsiteY0" fmla="*/ 0 h 451188"/>
                  <a:gd name="connsiteX1" fmla="*/ 2088006 w 2088006"/>
                  <a:gd name="connsiteY1" fmla="*/ 0 h 451188"/>
                  <a:gd name="connsiteX2" fmla="*/ 2088006 w 2088006"/>
                  <a:gd name="connsiteY2" fmla="*/ 451188 h 451188"/>
                  <a:gd name="connsiteX3" fmla="*/ 0 w 2088006"/>
                  <a:gd name="connsiteY3" fmla="*/ 451188 h 4511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2088006" h="451188">
                    <a:moveTo>
                      <a:pt x="0" y="0"/>
                    </a:moveTo>
                    <a:lnTo>
                      <a:pt x="2088006" y="0"/>
                    </a:lnTo>
                    <a:lnTo>
                      <a:pt x="2088006" y="451188"/>
                    </a:lnTo>
                    <a:lnTo>
                      <a:pt x="0" y="451188"/>
                    </a:lnTo>
                    <a:close/>
                  </a:path>
                </a:pathLst>
              </a:custGeom>
              <a:ln>
                <a:solidFill>
                  <a:schemeClr val="tx1"/>
                </a:solidFill>
              </a:ln>
            </p:spPr>
          </p:pic>
          <p:pic>
            <p:nvPicPr>
              <p:cNvPr id="59" name="Picture 58" descr="飞机飞在天空中&#10;&#10;中度可信度描述已自动生成">
                <a:extLst>
                  <a:ext uri="{FF2B5EF4-FFF2-40B4-BE49-F238E27FC236}">
                    <a16:creationId xmlns:a16="http://schemas.microsoft.com/office/drawing/2014/main" id="{9410B84A-046F-30DE-91AA-743C596615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50000"/>
                        </a14:imgEffect>
                        <a14:imgEffect>
                          <a14:brightnessContrast bright="40000"/>
                        </a14:imgEffect>
                      </a14:imgLayer>
                    </a14:imgProps>
                  </a:ext>
                </a:extLst>
              </a:blip>
              <a:srcRect l="28321" t="65617" r="54108" b="28828"/>
              <a:stretch/>
            </p:blipFill>
            <p:spPr>
              <a:xfrm flipH="1">
                <a:off x="4085710" y="3383785"/>
                <a:ext cx="2313690" cy="521822"/>
              </a:xfrm>
              <a:custGeom>
                <a:avLst/>
                <a:gdLst>
                  <a:gd name="connsiteX0" fmla="*/ 0 w 2088006"/>
                  <a:gd name="connsiteY0" fmla="*/ 0 h 451188"/>
                  <a:gd name="connsiteX1" fmla="*/ 2088006 w 2088006"/>
                  <a:gd name="connsiteY1" fmla="*/ 0 h 451188"/>
                  <a:gd name="connsiteX2" fmla="*/ 2088006 w 2088006"/>
                  <a:gd name="connsiteY2" fmla="*/ 451188 h 451188"/>
                  <a:gd name="connsiteX3" fmla="*/ 0 w 2088006"/>
                  <a:gd name="connsiteY3" fmla="*/ 451188 h 4511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2088006" h="451188">
                    <a:moveTo>
                      <a:pt x="0" y="0"/>
                    </a:moveTo>
                    <a:lnTo>
                      <a:pt x="2088006" y="0"/>
                    </a:lnTo>
                    <a:lnTo>
                      <a:pt x="2088006" y="451188"/>
                    </a:lnTo>
                    <a:lnTo>
                      <a:pt x="0" y="451188"/>
                    </a:lnTo>
                    <a:close/>
                  </a:path>
                </a:pathLst>
              </a:custGeom>
              <a:ln>
                <a:solidFill>
                  <a:schemeClr val="tx1"/>
                </a:solidFill>
              </a:ln>
            </p:spPr>
          </p:pic>
          <p:sp>
            <p:nvSpPr>
              <p:cNvPr id="26" name="矩形 17">
                <a:extLst>
                  <a:ext uri="{FF2B5EF4-FFF2-40B4-BE49-F238E27FC236}">
                    <a16:creationId xmlns:a16="http://schemas.microsoft.com/office/drawing/2014/main" id="{B7BFF12E-E5B8-4B19-AB28-AED6BBF4914C}"/>
                  </a:ext>
                </a:extLst>
              </p:cNvPr>
              <p:cNvSpPr/>
              <p:nvPr/>
            </p:nvSpPr>
            <p:spPr>
              <a:xfrm>
                <a:off x="6399400" y="2787447"/>
                <a:ext cx="886781" cy="46166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zh-CN" sz="2400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Bcl-2</a:t>
                </a:r>
                <a:endParaRPr lang="zh-CN" altLang="en-US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矩形 18">
                <a:extLst>
                  <a:ext uri="{FF2B5EF4-FFF2-40B4-BE49-F238E27FC236}">
                    <a16:creationId xmlns:a16="http://schemas.microsoft.com/office/drawing/2014/main" id="{6543A84E-3BE5-4789-A157-4F3C2180486C}"/>
                  </a:ext>
                </a:extLst>
              </p:cNvPr>
              <p:cNvSpPr/>
              <p:nvPr/>
            </p:nvSpPr>
            <p:spPr>
              <a:xfrm>
                <a:off x="6373273" y="3379107"/>
                <a:ext cx="1091966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zh-CN" sz="2400" dirty="0" err="1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Bcl</a:t>
                </a:r>
                <a:r>
                  <a:rPr kumimoji="1" lang="en-US" altLang="zh-CN" sz="2400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-XL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5AF0C147-D8D5-4B0E-990E-957828149DE3}"/>
                  </a:ext>
                </a:extLst>
              </p:cNvPr>
              <p:cNvSpPr txBox="1"/>
              <p:nvPr/>
            </p:nvSpPr>
            <p:spPr>
              <a:xfrm>
                <a:off x="3566579" y="2856254"/>
                <a:ext cx="54448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27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9A5A38F2-DFBC-4DF5-9E5B-BE7F7E579F5D}"/>
                  </a:ext>
                </a:extLst>
              </p:cNvPr>
              <p:cNvSpPr txBox="1"/>
              <p:nvPr/>
            </p:nvSpPr>
            <p:spPr>
              <a:xfrm>
                <a:off x="3566579" y="3386504"/>
                <a:ext cx="767231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27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18C04C3F-4A61-4E0A-AEED-220FDC1A968C}"/>
                  </a:ext>
                </a:extLst>
              </p:cNvPr>
              <p:cNvSpPr txBox="1"/>
              <p:nvPr/>
            </p:nvSpPr>
            <p:spPr>
              <a:xfrm>
                <a:off x="3324689" y="2281661"/>
                <a:ext cx="946061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文本框 24">
                <a:extLst>
                  <a:ext uri="{FF2B5EF4-FFF2-40B4-BE49-F238E27FC236}">
                    <a16:creationId xmlns:a16="http://schemas.microsoft.com/office/drawing/2014/main" id="{2FFC90E5-5FC5-DAF9-360B-6C28CED4FA41}"/>
                  </a:ext>
                </a:extLst>
              </p:cNvPr>
              <p:cNvSpPr txBox="1"/>
              <p:nvPr/>
            </p:nvSpPr>
            <p:spPr>
              <a:xfrm>
                <a:off x="6405763" y="5135198"/>
                <a:ext cx="1229824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zh-CN" sz="2400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PDCD4</a:t>
                </a:r>
                <a:endParaRPr kumimoji="1" lang="zh-CN" altLang="en-US" sz="24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44" name="矩形 38">
                <a:extLst>
                  <a:ext uri="{FF2B5EF4-FFF2-40B4-BE49-F238E27FC236}">
                    <a16:creationId xmlns:a16="http://schemas.microsoft.com/office/drawing/2014/main" id="{71EFB3F6-69E6-76D9-CDC2-82F011589982}"/>
                  </a:ext>
                </a:extLst>
              </p:cNvPr>
              <p:cNvSpPr/>
              <p:nvPr/>
            </p:nvSpPr>
            <p:spPr>
              <a:xfrm>
                <a:off x="6379111" y="3879341"/>
                <a:ext cx="1946165" cy="461665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zh-CN" sz="2400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C-caspase3</a:t>
                </a:r>
                <a:endParaRPr lang="zh-CN" altLang="en-US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矩形 46">
                <a:extLst>
                  <a:ext uri="{FF2B5EF4-FFF2-40B4-BE49-F238E27FC236}">
                    <a16:creationId xmlns:a16="http://schemas.microsoft.com/office/drawing/2014/main" id="{F1663737-98B3-2DB6-51C5-7F3BBF0ED489}"/>
                  </a:ext>
                </a:extLst>
              </p:cNvPr>
              <p:cNvSpPr/>
              <p:nvPr/>
            </p:nvSpPr>
            <p:spPr>
              <a:xfrm>
                <a:off x="6330136" y="4509781"/>
                <a:ext cx="1432443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zh-CN" sz="2400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TNFAIP3</a:t>
                </a:r>
                <a:endParaRPr lang="zh-CN" altLang="en-US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3" name="Picture 62" descr="图片包含 游戏机&#10;&#10;描述已自动生成">
                <a:extLst>
                  <a:ext uri="{FF2B5EF4-FFF2-40B4-BE49-F238E27FC236}">
                    <a16:creationId xmlns:a16="http://schemas.microsoft.com/office/drawing/2014/main" id="{89BA8B8C-9F62-C490-3BA2-3B6235F030D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57489" t="42463" r="24326" b="50009"/>
              <a:stretch/>
            </p:blipFill>
            <p:spPr>
              <a:xfrm flipH="1">
                <a:off x="4085709" y="4508584"/>
                <a:ext cx="2313695" cy="490180"/>
              </a:xfrm>
              <a:custGeom>
                <a:avLst/>
                <a:gdLst>
                  <a:gd name="connsiteX0" fmla="*/ 0 w 2088006"/>
                  <a:gd name="connsiteY0" fmla="*/ 0 h 451188"/>
                  <a:gd name="connsiteX1" fmla="*/ 2088006 w 2088006"/>
                  <a:gd name="connsiteY1" fmla="*/ 0 h 451188"/>
                  <a:gd name="connsiteX2" fmla="*/ 2088006 w 2088006"/>
                  <a:gd name="connsiteY2" fmla="*/ 451188 h 451188"/>
                  <a:gd name="connsiteX3" fmla="*/ 0 w 2088006"/>
                  <a:gd name="connsiteY3" fmla="*/ 451188 h 4511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2088006" h="451188">
                    <a:moveTo>
                      <a:pt x="0" y="0"/>
                    </a:moveTo>
                    <a:lnTo>
                      <a:pt x="2088006" y="0"/>
                    </a:lnTo>
                    <a:lnTo>
                      <a:pt x="2088006" y="451188"/>
                    </a:lnTo>
                    <a:lnTo>
                      <a:pt x="0" y="451188"/>
                    </a:lnTo>
                    <a:close/>
                  </a:path>
                </a:pathLst>
              </a:custGeom>
              <a:ln>
                <a:solidFill>
                  <a:schemeClr val="tx1"/>
                </a:solidFill>
              </a:ln>
            </p:spPr>
          </p:pic>
          <p:pic>
            <p:nvPicPr>
              <p:cNvPr id="48" name="图片 8" descr="图片包含 游戏机, 吉他&#10;&#10;描述已自动生成">
                <a:extLst>
                  <a:ext uri="{FF2B5EF4-FFF2-40B4-BE49-F238E27FC236}">
                    <a16:creationId xmlns:a16="http://schemas.microsoft.com/office/drawing/2014/main" id="{C35F1773-724D-59E0-EBAE-DB274DFE36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34374" t="35591" r="47633" b="57167"/>
              <a:stretch/>
            </p:blipFill>
            <p:spPr>
              <a:xfrm flipH="1">
                <a:off x="4085701" y="5106804"/>
                <a:ext cx="2313697" cy="52182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1" name="图片 20" descr="飞机飞在天空中&#10;&#10;低可信度描述已自动生成">
                <a:extLst>
                  <a:ext uri="{FF2B5EF4-FFF2-40B4-BE49-F238E27FC236}">
                    <a16:creationId xmlns:a16="http://schemas.microsoft.com/office/drawing/2014/main" id="{84EE30F7-867E-89EF-E052-2FB494388E8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rcRect l="46314" t="39270" r="35317" b="52432"/>
              <a:stretch/>
            </p:blipFill>
            <p:spPr>
              <a:xfrm flipH="1">
                <a:off x="4085709" y="3973617"/>
                <a:ext cx="2313693" cy="45628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B766296D-1A2C-63FB-733B-D6F51C4504ED}"/>
                  </a:ext>
                </a:extLst>
              </p:cNvPr>
              <p:cNvSpPr txBox="1"/>
              <p:nvPr/>
            </p:nvSpPr>
            <p:spPr>
              <a:xfrm rot="19800731">
                <a:off x="4089939" y="1720894"/>
                <a:ext cx="2581219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2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ON</a:t>
                </a:r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 + </a:t>
                </a:r>
                <a:r>
                  <a:rPr lang="en-US" altLang="zh-CN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Vector</a:t>
                </a:r>
                <a:endParaRPr lang="en-US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D6676097-D2F1-C928-4483-8DE96DCCD147}"/>
                  </a:ext>
                </a:extLst>
              </p:cNvPr>
              <p:cNvSpPr txBox="1"/>
              <p:nvPr/>
            </p:nvSpPr>
            <p:spPr>
              <a:xfrm rot="19777648">
                <a:off x="4561240" y="884837"/>
                <a:ext cx="6101644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YTHDF1-OE + </a:t>
                </a:r>
                <a:r>
                  <a:rPr lang="en-US" sz="2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ON</a:t>
                </a:r>
                <a:endParaRPr lang="en-US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26FA3AF5-37E3-AEC5-AA8A-A0A5BA609546}"/>
                  </a:ext>
                </a:extLst>
              </p:cNvPr>
              <p:cNvSpPr txBox="1"/>
              <p:nvPr/>
            </p:nvSpPr>
            <p:spPr>
              <a:xfrm rot="19822858">
                <a:off x="5404978" y="936924"/>
                <a:ext cx="6101644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YTHDF1-OE + siTLR2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DCEFDD88-081C-86A0-2B61-7296E73EE970}"/>
                  </a:ext>
                </a:extLst>
              </p:cNvPr>
              <p:cNvSpPr txBox="1"/>
              <p:nvPr/>
            </p:nvSpPr>
            <p:spPr>
              <a:xfrm>
                <a:off x="3566579" y="3827643"/>
                <a:ext cx="5502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19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0D003617-3565-3BA8-9B1E-8F1871B119EC}"/>
                  </a:ext>
                </a:extLst>
              </p:cNvPr>
              <p:cNvSpPr txBox="1"/>
              <p:nvPr/>
            </p:nvSpPr>
            <p:spPr>
              <a:xfrm>
                <a:off x="3566579" y="4160416"/>
                <a:ext cx="5502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DEDF531B-D742-1199-A200-28DC29CFFE1B}"/>
                  </a:ext>
                </a:extLst>
              </p:cNvPr>
              <p:cNvSpPr txBox="1"/>
              <p:nvPr/>
            </p:nvSpPr>
            <p:spPr>
              <a:xfrm>
                <a:off x="3566579" y="4578404"/>
                <a:ext cx="54448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D98D012D-5854-CC6A-BC60-92569C588461}"/>
                  </a:ext>
                </a:extLst>
              </p:cNvPr>
              <p:cNvSpPr txBox="1"/>
              <p:nvPr/>
            </p:nvSpPr>
            <p:spPr>
              <a:xfrm>
                <a:off x="3566579" y="5144443"/>
                <a:ext cx="54448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31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EF51101E-218F-CF0F-8F90-D530F7886907}"/>
                  </a:ext>
                </a:extLst>
              </p:cNvPr>
              <p:cNvSpPr txBox="1"/>
              <p:nvPr/>
            </p:nvSpPr>
            <p:spPr>
              <a:xfrm>
                <a:off x="3566579" y="5732302"/>
                <a:ext cx="54448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42</a:t>
                </a: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8BC0C86-397E-751C-0CEB-814CD3234792}"/>
                </a:ext>
              </a:extLst>
            </p:cNvPr>
            <p:cNvSpPr txBox="1"/>
            <p:nvPr/>
          </p:nvSpPr>
          <p:spPr>
            <a:xfrm>
              <a:off x="3333995" y="1121641"/>
              <a:ext cx="17056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FaDu</a:t>
              </a:r>
              <a:endParaRPr 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081BF7AC-090F-A1A2-2B92-0D067DC88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5235271" y="6106204"/>
            <a:ext cx="2743200" cy="365125"/>
          </a:xfrm>
        </p:spPr>
        <p:txBody>
          <a:bodyPr/>
          <a:lstStyle/>
          <a:p>
            <a:fld id="{C9C2E767-D159-4FE5-AEFF-9874D8CE979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8295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3B38DDFA-D45F-5343-ED7F-04B5908000BA}"/>
              </a:ext>
            </a:extLst>
          </p:cNvPr>
          <p:cNvGrpSpPr/>
          <p:nvPr/>
        </p:nvGrpSpPr>
        <p:grpSpPr>
          <a:xfrm>
            <a:off x="6521240" y="631064"/>
            <a:ext cx="2124413" cy="1206562"/>
            <a:chOff x="87229" y="-100806"/>
            <a:chExt cx="3461082" cy="1206562"/>
          </a:xfrm>
        </p:grpSpPr>
        <p:sp>
          <p:nvSpPr>
            <p:cNvPr id="24" name="文本框 16">
              <a:extLst>
                <a:ext uri="{FF2B5EF4-FFF2-40B4-BE49-F238E27FC236}">
                  <a16:creationId xmlns:a16="http://schemas.microsoft.com/office/drawing/2014/main" id="{3D86EA04-02F0-1D4F-9CC7-724F6A88F5E4}"/>
                </a:ext>
              </a:extLst>
            </p:cNvPr>
            <p:cNvSpPr txBox="1"/>
            <p:nvPr/>
          </p:nvSpPr>
          <p:spPr>
            <a:xfrm>
              <a:off x="87229" y="644091"/>
              <a:ext cx="244650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CN" sz="24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210915-16</a:t>
              </a:r>
              <a:r>
                <a:rPr kumimoji="1" lang="zh-CN" altLang="en-US" sz="24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 </a:t>
              </a:r>
              <a:r>
                <a:rPr kumimoji="1" lang="en-US" altLang="zh-CN" sz="24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10%</a:t>
              </a:r>
              <a:r>
                <a:rPr kumimoji="1" lang="zh-CN" altLang="en-US" sz="24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4" name="文本框 16">
              <a:extLst>
                <a:ext uri="{FF2B5EF4-FFF2-40B4-BE49-F238E27FC236}">
                  <a16:creationId xmlns:a16="http://schemas.microsoft.com/office/drawing/2014/main" id="{3603F464-3D2D-5178-5942-97E83393DDC1}"/>
                </a:ext>
              </a:extLst>
            </p:cNvPr>
            <p:cNvSpPr txBox="1"/>
            <p:nvPr/>
          </p:nvSpPr>
          <p:spPr>
            <a:xfrm>
              <a:off x="135197" y="-100806"/>
              <a:ext cx="341311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kumimoji="1" lang="en-US" altLang="zh-CN" sz="24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210824-26</a:t>
              </a:r>
              <a:r>
                <a:rPr kumimoji="1" lang="zh-CN" altLang="en-US" sz="24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 </a:t>
              </a:r>
              <a:r>
                <a:rPr kumimoji="1" lang="en-US" altLang="zh-CN" sz="24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10% + 15%</a:t>
              </a:r>
              <a:r>
                <a:rPr kumimoji="1" lang="zh-CN" altLang="en-US" sz="24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rPr>
                <a:t> </a:t>
              </a:r>
            </a:p>
          </p:txBody>
        </p:sp>
        <p:sp>
          <p:nvSpPr>
            <p:cNvPr id="35" name="文本框 1">
              <a:extLst>
                <a:ext uri="{FF2B5EF4-FFF2-40B4-BE49-F238E27FC236}">
                  <a16:creationId xmlns:a16="http://schemas.microsoft.com/office/drawing/2014/main" id="{D3BAFC20-1A4A-2F51-16D2-13F0290C1D2A}"/>
                </a:ext>
              </a:extLst>
            </p:cNvPr>
            <p:cNvSpPr txBox="1"/>
            <p:nvPr/>
          </p:nvSpPr>
          <p:spPr>
            <a:xfrm>
              <a:off x="133056" y="284459"/>
              <a:ext cx="29338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0810 + 0819 protein</a:t>
              </a:r>
              <a:endParaRPr kumimoji="1" lang="zh-CN" alt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9E44F3D7-B28D-701C-D241-CE1141EA50F8}"/>
              </a:ext>
            </a:extLst>
          </p:cNvPr>
          <p:cNvGrpSpPr/>
          <p:nvPr/>
        </p:nvGrpSpPr>
        <p:grpSpPr>
          <a:xfrm>
            <a:off x="-215318" y="1012146"/>
            <a:ext cx="7798880" cy="5492021"/>
            <a:chOff x="2879942" y="814726"/>
            <a:chExt cx="7798880" cy="5492021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AA679C71-6F47-3DC1-7931-F6267F199759}"/>
                </a:ext>
              </a:extLst>
            </p:cNvPr>
            <p:cNvGrpSpPr/>
            <p:nvPr/>
          </p:nvGrpSpPr>
          <p:grpSpPr>
            <a:xfrm>
              <a:off x="2879942" y="814726"/>
              <a:ext cx="7798880" cy="5492021"/>
              <a:chOff x="2879942" y="814726"/>
              <a:chExt cx="7798880" cy="5492021"/>
            </a:xfrm>
          </p:grpSpPr>
          <p:pic>
            <p:nvPicPr>
              <p:cNvPr id="5" name="图片 4" descr="空中有架飞机的黑白照&#10;&#10;低可信度描述已自动生成">
                <a:extLst>
                  <a:ext uri="{FF2B5EF4-FFF2-40B4-BE49-F238E27FC236}">
                    <a16:creationId xmlns:a16="http://schemas.microsoft.com/office/drawing/2014/main" id="{EC6837EF-97D2-1043-9483-6133BA6EC38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</a:extLst>
              </a:blip>
              <a:srcRect l="48802" t="53599" r="17631" b="41638"/>
              <a:stretch/>
            </p:blipFill>
            <p:spPr>
              <a:xfrm>
                <a:off x="3590723" y="5845082"/>
                <a:ext cx="4212584" cy="46166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6569A41A-C499-844C-8B4B-5322E64B21E2}"/>
                  </a:ext>
                </a:extLst>
              </p:cNvPr>
              <p:cNvSpPr txBox="1"/>
              <p:nvPr/>
            </p:nvSpPr>
            <p:spPr>
              <a:xfrm>
                <a:off x="7901672" y="5753893"/>
                <a:ext cx="1124026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zh-CN" altLang="en-US" sz="2400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𝛽</a:t>
                </a:r>
                <a:r>
                  <a:rPr kumimoji="1" lang="en-US" altLang="zh-CN" sz="2400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-actin</a:t>
                </a:r>
              </a:p>
            </p:txBody>
          </p:sp>
          <p:pic>
            <p:nvPicPr>
              <p:cNvPr id="57" name="Picture 56" descr="图片包含 水, 旧, 标志, 大&#10;&#10;描述已自动生成">
                <a:extLst>
                  <a:ext uri="{FF2B5EF4-FFF2-40B4-BE49-F238E27FC236}">
                    <a16:creationId xmlns:a16="http://schemas.microsoft.com/office/drawing/2014/main" id="{D8D27A2E-814B-5AEE-E21C-67425489082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harpenSoften amount="50000"/>
                        </a14:imgEffect>
                        <a14:imgEffect>
                          <a14:brightnessContrast bright="40000"/>
                        </a14:imgEffect>
                      </a14:imgLayer>
                    </a14:imgProps>
                  </a:ext>
                </a:extLst>
              </a:blip>
              <a:srcRect l="33867" t="61705" r="33071" b="33728"/>
              <a:stretch/>
            </p:blipFill>
            <p:spPr>
              <a:xfrm>
                <a:off x="3648102" y="2761003"/>
                <a:ext cx="4192659" cy="520157"/>
              </a:xfrm>
              <a:custGeom>
                <a:avLst/>
                <a:gdLst>
                  <a:gd name="connsiteX0" fmla="*/ 0 w 2088006"/>
                  <a:gd name="connsiteY0" fmla="*/ 0 h 451188"/>
                  <a:gd name="connsiteX1" fmla="*/ 2088006 w 2088006"/>
                  <a:gd name="connsiteY1" fmla="*/ 0 h 451188"/>
                  <a:gd name="connsiteX2" fmla="*/ 2088006 w 2088006"/>
                  <a:gd name="connsiteY2" fmla="*/ 451188 h 451188"/>
                  <a:gd name="connsiteX3" fmla="*/ 0 w 2088006"/>
                  <a:gd name="connsiteY3" fmla="*/ 451188 h 4511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2088006" h="451188">
                    <a:moveTo>
                      <a:pt x="0" y="0"/>
                    </a:moveTo>
                    <a:lnTo>
                      <a:pt x="2088006" y="0"/>
                    </a:lnTo>
                    <a:lnTo>
                      <a:pt x="2088006" y="451188"/>
                    </a:lnTo>
                    <a:lnTo>
                      <a:pt x="0" y="451188"/>
                    </a:lnTo>
                    <a:close/>
                  </a:path>
                </a:pathLst>
              </a:custGeom>
              <a:ln>
                <a:solidFill>
                  <a:schemeClr val="tx1"/>
                </a:solidFill>
              </a:ln>
            </p:spPr>
          </p:pic>
          <p:pic>
            <p:nvPicPr>
              <p:cNvPr id="59" name="Picture 58" descr="飞机飞在天空中&#10;&#10;中度可信度描述已自动生成">
                <a:extLst>
                  <a:ext uri="{FF2B5EF4-FFF2-40B4-BE49-F238E27FC236}">
                    <a16:creationId xmlns:a16="http://schemas.microsoft.com/office/drawing/2014/main" id="{9410B84A-046F-30DE-91AA-743C596615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sharpenSoften amount="50000"/>
                        </a14:imgEffect>
                        <a14:imgEffect>
                          <a14:brightnessContrast bright="40000"/>
                        </a14:imgEffect>
                      </a14:imgLayer>
                    </a14:imgProps>
                  </a:ext>
                </a:extLst>
              </a:blip>
              <a:srcRect l="25154" t="65617" r="42882" b="28928"/>
              <a:stretch/>
            </p:blipFill>
            <p:spPr>
              <a:xfrm>
                <a:off x="3648102" y="3383785"/>
                <a:ext cx="4208779" cy="512497"/>
              </a:xfrm>
              <a:custGeom>
                <a:avLst/>
                <a:gdLst>
                  <a:gd name="connsiteX0" fmla="*/ 0 w 2088006"/>
                  <a:gd name="connsiteY0" fmla="*/ 0 h 451188"/>
                  <a:gd name="connsiteX1" fmla="*/ 2088006 w 2088006"/>
                  <a:gd name="connsiteY1" fmla="*/ 0 h 451188"/>
                  <a:gd name="connsiteX2" fmla="*/ 2088006 w 2088006"/>
                  <a:gd name="connsiteY2" fmla="*/ 451188 h 451188"/>
                  <a:gd name="connsiteX3" fmla="*/ 0 w 2088006"/>
                  <a:gd name="connsiteY3" fmla="*/ 451188 h 4511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2088006" h="451188">
                    <a:moveTo>
                      <a:pt x="0" y="0"/>
                    </a:moveTo>
                    <a:lnTo>
                      <a:pt x="2088006" y="0"/>
                    </a:lnTo>
                    <a:lnTo>
                      <a:pt x="2088006" y="451188"/>
                    </a:lnTo>
                    <a:lnTo>
                      <a:pt x="0" y="451188"/>
                    </a:lnTo>
                    <a:close/>
                  </a:path>
                </a:pathLst>
              </a:custGeom>
              <a:ln>
                <a:solidFill>
                  <a:schemeClr val="tx1"/>
                </a:solidFill>
              </a:ln>
            </p:spPr>
          </p:pic>
          <p:sp>
            <p:nvSpPr>
              <p:cNvPr id="26" name="矩形 17">
                <a:extLst>
                  <a:ext uri="{FF2B5EF4-FFF2-40B4-BE49-F238E27FC236}">
                    <a16:creationId xmlns:a16="http://schemas.microsoft.com/office/drawing/2014/main" id="{B7BFF12E-E5B8-4B19-AB28-AED6BBF4914C}"/>
                  </a:ext>
                </a:extLst>
              </p:cNvPr>
              <p:cNvSpPr/>
              <p:nvPr/>
            </p:nvSpPr>
            <p:spPr>
              <a:xfrm>
                <a:off x="8050953" y="2903396"/>
                <a:ext cx="886781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zh-CN" sz="2400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Bcl-2</a:t>
                </a:r>
                <a:endParaRPr lang="zh-CN" altLang="en-US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" name="矩形 18">
                <a:extLst>
                  <a:ext uri="{FF2B5EF4-FFF2-40B4-BE49-F238E27FC236}">
                    <a16:creationId xmlns:a16="http://schemas.microsoft.com/office/drawing/2014/main" id="{6543A84E-3BE5-4789-A157-4F3C2180486C}"/>
                  </a:ext>
                </a:extLst>
              </p:cNvPr>
              <p:cNvSpPr/>
              <p:nvPr/>
            </p:nvSpPr>
            <p:spPr>
              <a:xfrm>
                <a:off x="7991303" y="3487407"/>
                <a:ext cx="1091966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zh-CN" sz="2400" dirty="0" err="1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Bcl</a:t>
                </a:r>
                <a:r>
                  <a:rPr kumimoji="1" lang="en-US" altLang="zh-CN" sz="2400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-XL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5AF0C147-D8D5-4B0E-990E-957828149DE3}"/>
                  </a:ext>
                </a:extLst>
              </p:cNvPr>
              <p:cNvSpPr txBox="1"/>
              <p:nvPr/>
            </p:nvSpPr>
            <p:spPr>
              <a:xfrm>
                <a:off x="3086595" y="2939939"/>
                <a:ext cx="54448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27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9A5A38F2-DFBC-4DF5-9E5B-BE7F7E579F5D}"/>
                  </a:ext>
                </a:extLst>
              </p:cNvPr>
              <p:cNvSpPr txBox="1"/>
              <p:nvPr/>
            </p:nvSpPr>
            <p:spPr>
              <a:xfrm>
                <a:off x="3086595" y="3470189"/>
                <a:ext cx="767231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27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18C04C3F-4A61-4E0A-AEED-220FDC1A968C}"/>
                  </a:ext>
                </a:extLst>
              </p:cNvPr>
              <p:cNvSpPr txBox="1"/>
              <p:nvPr/>
            </p:nvSpPr>
            <p:spPr>
              <a:xfrm>
                <a:off x="2879942" y="2409689"/>
                <a:ext cx="946061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文本框 24">
                <a:extLst>
                  <a:ext uri="{FF2B5EF4-FFF2-40B4-BE49-F238E27FC236}">
                    <a16:creationId xmlns:a16="http://schemas.microsoft.com/office/drawing/2014/main" id="{2FFC90E5-5FC5-DAF9-360B-6C28CED4FA41}"/>
                  </a:ext>
                </a:extLst>
              </p:cNvPr>
              <p:cNvSpPr txBox="1"/>
              <p:nvPr/>
            </p:nvSpPr>
            <p:spPr>
              <a:xfrm>
                <a:off x="7848773" y="5271187"/>
                <a:ext cx="1229824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zh-CN" sz="2400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PDCD4</a:t>
                </a:r>
                <a:endParaRPr kumimoji="1" lang="zh-CN" altLang="en-US" sz="2400" dirty="0">
                  <a:latin typeface="Arial" panose="020B0604020202020204" pitchFamily="34" charset="0"/>
                  <a:ea typeface="Microsoft YaHei" panose="020B0503020204020204" pitchFamily="34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44" name="矩形 38">
                <a:extLst>
                  <a:ext uri="{FF2B5EF4-FFF2-40B4-BE49-F238E27FC236}">
                    <a16:creationId xmlns:a16="http://schemas.microsoft.com/office/drawing/2014/main" id="{71EFB3F6-69E6-76D9-CDC2-82F011589982}"/>
                  </a:ext>
                </a:extLst>
              </p:cNvPr>
              <p:cNvSpPr/>
              <p:nvPr/>
            </p:nvSpPr>
            <p:spPr>
              <a:xfrm>
                <a:off x="7803307" y="3878618"/>
                <a:ext cx="1495052" cy="83099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zh-CN" sz="2400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C-caspase3</a:t>
                </a:r>
                <a:endParaRPr lang="zh-CN" altLang="en-US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矩形 46">
                <a:extLst>
                  <a:ext uri="{FF2B5EF4-FFF2-40B4-BE49-F238E27FC236}">
                    <a16:creationId xmlns:a16="http://schemas.microsoft.com/office/drawing/2014/main" id="{F1663737-98B3-2DB6-51C5-7F3BBF0ED489}"/>
                  </a:ext>
                </a:extLst>
              </p:cNvPr>
              <p:cNvSpPr/>
              <p:nvPr/>
            </p:nvSpPr>
            <p:spPr>
              <a:xfrm>
                <a:off x="7836957" y="4725771"/>
                <a:ext cx="1432443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zh-CN" sz="2400" dirty="0">
                    <a:latin typeface="Arial" panose="020B0604020202020204" pitchFamily="34" charset="0"/>
                    <a:ea typeface="Microsoft YaHei" panose="020B0503020204020204" pitchFamily="34" charset="-122"/>
                    <a:cs typeface="Arial" panose="020B0604020202020204" pitchFamily="34" charset="0"/>
                  </a:rPr>
                  <a:t>TNFAIP3</a:t>
                </a:r>
                <a:endParaRPr lang="zh-CN" altLang="en-US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3" name="Picture 62" descr="图片包含 游戏机&#10;&#10;描述已自动生成">
                <a:extLst>
                  <a:ext uri="{FF2B5EF4-FFF2-40B4-BE49-F238E27FC236}">
                    <a16:creationId xmlns:a16="http://schemas.microsoft.com/office/drawing/2014/main" id="{89BA8B8C-9F62-C490-3BA2-3B6235F030D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53545" t="42360" r="13373" b="49649"/>
              <a:stretch/>
            </p:blipFill>
            <p:spPr>
              <a:xfrm>
                <a:off x="3599479" y="4632761"/>
                <a:ext cx="4208779" cy="520322"/>
              </a:xfrm>
              <a:custGeom>
                <a:avLst/>
                <a:gdLst>
                  <a:gd name="connsiteX0" fmla="*/ 0 w 2088006"/>
                  <a:gd name="connsiteY0" fmla="*/ 0 h 451188"/>
                  <a:gd name="connsiteX1" fmla="*/ 2088006 w 2088006"/>
                  <a:gd name="connsiteY1" fmla="*/ 0 h 451188"/>
                  <a:gd name="connsiteX2" fmla="*/ 2088006 w 2088006"/>
                  <a:gd name="connsiteY2" fmla="*/ 451188 h 451188"/>
                  <a:gd name="connsiteX3" fmla="*/ 0 w 2088006"/>
                  <a:gd name="connsiteY3" fmla="*/ 451188 h 45118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2088006" h="451188">
                    <a:moveTo>
                      <a:pt x="0" y="0"/>
                    </a:moveTo>
                    <a:lnTo>
                      <a:pt x="2088006" y="0"/>
                    </a:lnTo>
                    <a:lnTo>
                      <a:pt x="2088006" y="451188"/>
                    </a:lnTo>
                    <a:lnTo>
                      <a:pt x="0" y="451188"/>
                    </a:lnTo>
                    <a:close/>
                  </a:path>
                </a:pathLst>
              </a:custGeom>
              <a:ln>
                <a:solidFill>
                  <a:schemeClr val="tx1"/>
                </a:solidFill>
              </a:ln>
            </p:spPr>
          </p:pic>
          <p:pic>
            <p:nvPicPr>
              <p:cNvPr id="48" name="图片 8" descr="图片包含 游戏机, 吉他&#10;&#10;描述已自动生成">
                <a:extLst>
                  <a:ext uri="{FF2B5EF4-FFF2-40B4-BE49-F238E27FC236}">
                    <a16:creationId xmlns:a16="http://schemas.microsoft.com/office/drawing/2014/main" id="{C35F1773-724D-59E0-EBAE-DB274DFE36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31138" t="35867" r="36103" b="57852"/>
              <a:stretch/>
            </p:blipFill>
            <p:spPr>
              <a:xfrm>
                <a:off x="3594527" y="5262205"/>
                <a:ext cx="4212584" cy="47064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51" name="图片 20" descr="飞机飞在天空中&#10;&#10;低可信度描述已自动生成">
                <a:extLst>
                  <a:ext uri="{FF2B5EF4-FFF2-40B4-BE49-F238E27FC236}">
                    <a16:creationId xmlns:a16="http://schemas.microsoft.com/office/drawing/2014/main" id="{84EE30F7-867E-89EF-E052-2FB494388E8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rcRect l="42845" t="39270" r="23740" b="51816"/>
              <a:stretch/>
            </p:blipFill>
            <p:spPr>
              <a:xfrm>
                <a:off x="3628178" y="3973616"/>
                <a:ext cx="4208779" cy="49017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B766296D-1A2C-63FB-733B-D6F51C4504ED}"/>
                  </a:ext>
                </a:extLst>
              </p:cNvPr>
              <p:cNvSpPr txBox="1"/>
              <p:nvPr/>
            </p:nvSpPr>
            <p:spPr>
              <a:xfrm rot="19800731">
                <a:off x="5631337" y="1698595"/>
                <a:ext cx="2581219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2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ON</a:t>
                </a:r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 + </a:t>
                </a:r>
                <a:r>
                  <a:rPr lang="en-US" altLang="zh-CN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Vector</a:t>
                </a:r>
                <a:endParaRPr lang="en-US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D6676097-D2F1-C928-4483-8DE96DCCD147}"/>
                  </a:ext>
                </a:extLst>
              </p:cNvPr>
              <p:cNvSpPr txBox="1"/>
              <p:nvPr/>
            </p:nvSpPr>
            <p:spPr>
              <a:xfrm rot="19777648">
                <a:off x="4577178" y="814726"/>
                <a:ext cx="6101644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YTHDF1-OE + </a:t>
                </a:r>
                <a:r>
                  <a:rPr lang="en-US" sz="2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CON</a:t>
                </a:r>
                <a:endParaRPr lang="en-US" sz="2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26FA3AF5-37E3-AEC5-AA8A-A0A5BA609546}"/>
                  </a:ext>
                </a:extLst>
              </p:cNvPr>
              <p:cNvSpPr txBox="1"/>
              <p:nvPr/>
            </p:nvSpPr>
            <p:spPr>
              <a:xfrm rot="19822858">
                <a:off x="3752620" y="835127"/>
                <a:ext cx="6101644" cy="461665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YTHDF1-OE + siTLR2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DCEFDD88-081C-86A0-2B61-7296E73EE970}"/>
                  </a:ext>
                </a:extLst>
              </p:cNvPr>
              <p:cNvSpPr txBox="1"/>
              <p:nvPr/>
            </p:nvSpPr>
            <p:spPr>
              <a:xfrm>
                <a:off x="3023324" y="3911328"/>
                <a:ext cx="5502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19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0D003617-3565-3BA8-9B1E-8F1871B119EC}"/>
                  </a:ext>
                </a:extLst>
              </p:cNvPr>
              <p:cNvSpPr txBox="1"/>
              <p:nvPr/>
            </p:nvSpPr>
            <p:spPr>
              <a:xfrm>
                <a:off x="3018119" y="4244101"/>
                <a:ext cx="55029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17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DEDF531B-D742-1199-A200-28DC29CFFE1B}"/>
                  </a:ext>
                </a:extLst>
              </p:cNvPr>
              <p:cNvSpPr txBox="1"/>
              <p:nvPr/>
            </p:nvSpPr>
            <p:spPr>
              <a:xfrm>
                <a:off x="3067522" y="4662089"/>
                <a:ext cx="54448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D98D012D-5854-CC6A-BC60-92569C588461}"/>
                  </a:ext>
                </a:extLst>
              </p:cNvPr>
              <p:cNvSpPr txBox="1"/>
              <p:nvPr/>
            </p:nvSpPr>
            <p:spPr>
              <a:xfrm>
                <a:off x="3017538" y="5303597"/>
                <a:ext cx="54448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31</a:t>
                </a:r>
              </a:p>
            </p:txBody>
          </p:sp>
          <p:sp>
            <p:nvSpPr>
              <p:cNvPr id="72" name="TextBox 71">
                <a:extLst>
                  <a:ext uri="{FF2B5EF4-FFF2-40B4-BE49-F238E27FC236}">
                    <a16:creationId xmlns:a16="http://schemas.microsoft.com/office/drawing/2014/main" id="{EF51101E-218F-CF0F-8F90-D530F7886907}"/>
                  </a:ext>
                </a:extLst>
              </p:cNvPr>
              <p:cNvSpPr txBox="1"/>
              <p:nvPr/>
            </p:nvSpPr>
            <p:spPr>
              <a:xfrm>
                <a:off x="3046237" y="5806964"/>
                <a:ext cx="54448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2400" dirty="0">
                    <a:latin typeface="Arial" panose="020B0604020202020204" pitchFamily="34" charset="0"/>
                    <a:cs typeface="Arial" panose="020B0604020202020204" pitchFamily="34" charset="0"/>
                  </a:rPr>
                  <a:t>42</a:t>
                </a: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8BC0C86-397E-751C-0CEB-814CD3234792}"/>
                </a:ext>
              </a:extLst>
            </p:cNvPr>
            <p:cNvSpPr txBox="1"/>
            <p:nvPr/>
          </p:nvSpPr>
          <p:spPr>
            <a:xfrm>
              <a:off x="3244329" y="1142443"/>
              <a:ext cx="17056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dirty="0">
                  <a:latin typeface="Arial" panose="020B0604020202020204" pitchFamily="34" charset="0"/>
                  <a:cs typeface="Arial" panose="020B0604020202020204" pitchFamily="34" charset="0"/>
                </a:rPr>
                <a:t>FaDu</a:t>
              </a:r>
              <a:endParaRPr lang="en-US" sz="2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081BF7AC-090F-A1A2-2B92-0D067DC88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678680" y="7118350"/>
            <a:ext cx="2743200" cy="365125"/>
          </a:xfrm>
        </p:spPr>
        <p:txBody>
          <a:bodyPr/>
          <a:lstStyle/>
          <a:p>
            <a:fld id="{C9C2E767-D159-4FE5-AEFF-9874D8CE9795}" type="slidenum">
              <a:rPr lang="en-US" smtClean="0"/>
              <a:t>2</a:t>
            </a:fld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A1B9BD6-A14E-9AE1-FD34-94AD7F117DED}"/>
              </a:ext>
            </a:extLst>
          </p:cNvPr>
          <p:cNvSpPr txBox="1"/>
          <p:nvPr/>
        </p:nvSpPr>
        <p:spPr>
          <a:xfrm rot="19800731">
            <a:off x="3306045" y="1910979"/>
            <a:ext cx="2581219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400" dirty="0">
                <a:latin typeface="Arial" panose="020B0604020202020204" pitchFamily="34" charset="0"/>
                <a:cs typeface="Arial" panose="020B0604020202020204" pitchFamily="34" charset="0"/>
              </a:rPr>
              <a:t>siTLR2+ </a:t>
            </a:r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2F079C2-627A-9F85-55A0-7ABAD20255A6}"/>
              </a:ext>
            </a:extLst>
          </p:cNvPr>
          <p:cNvSpPr txBox="1"/>
          <p:nvPr/>
        </p:nvSpPr>
        <p:spPr>
          <a:xfrm>
            <a:off x="941923" y="2607109"/>
            <a:ext cx="2338372" cy="40398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21357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85</Words>
  <Application>Microsoft Office PowerPoint</Application>
  <PresentationFormat>Widescreen</PresentationFormat>
  <Paragraphs>47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g ye</dc:creator>
  <cp:lastModifiedBy>jing ye</cp:lastModifiedBy>
  <cp:revision>1</cp:revision>
  <dcterms:created xsi:type="dcterms:W3CDTF">2023-04-07T09:24:40Z</dcterms:created>
  <dcterms:modified xsi:type="dcterms:W3CDTF">2023-04-07T09:34:36Z</dcterms:modified>
</cp:coreProperties>
</file>